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4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0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305EE-BB96-460C-B8F6-EF2AE0C23164}" type="datetimeFigureOut">
              <a:rPr lang="en-IN" smtClean="0"/>
              <a:t>21/12/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1BE3D-AAD2-41CB-9E55-18986B5E219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55075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305EE-BB96-460C-B8F6-EF2AE0C23164}" type="datetimeFigureOut">
              <a:rPr lang="en-IN" smtClean="0"/>
              <a:t>21/12/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1BE3D-AAD2-41CB-9E55-18986B5E219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964647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305EE-BB96-460C-B8F6-EF2AE0C23164}" type="datetimeFigureOut">
              <a:rPr lang="en-IN" smtClean="0"/>
              <a:t>21/12/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1BE3D-AAD2-41CB-9E55-18986B5E219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420678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305EE-BB96-460C-B8F6-EF2AE0C23164}" type="datetimeFigureOut">
              <a:rPr lang="en-IN" smtClean="0"/>
              <a:t>21/12/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1BE3D-AAD2-41CB-9E55-18986B5E219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73723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305EE-BB96-460C-B8F6-EF2AE0C23164}" type="datetimeFigureOut">
              <a:rPr lang="en-IN" smtClean="0"/>
              <a:t>21/12/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1BE3D-AAD2-41CB-9E55-18986B5E219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019181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305EE-BB96-460C-B8F6-EF2AE0C23164}" type="datetimeFigureOut">
              <a:rPr lang="en-IN" smtClean="0"/>
              <a:t>21/12/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1BE3D-AAD2-41CB-9E55-18986B5E219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5517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305EE-BB96-460C-B8F6-EF2AE0C23164}" type="datetimeFigureOut">
              <a:rPr lang="en-IN" smtClean="0"/>
              <a:t>21/12/22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1BE3D-AAD2-41CB-9E55-18986B5E219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57576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305EE-BB96-460C-B8F6-EF2AE0C23164}" type="datetimeFigureOut">
              <a:rPr lang="en-IN" smtClean="0"/>
              <a:t>21/12/22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1BE3D-AAD2-41CB-9E55-18986B5E219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350996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305EE-BB96-460C-B8F6-EF2AE0C23164}" type="datetimeFigureOut">
              <a:rPr lang="en-IN" smtClean="0"/>
              <a:t>21/12/22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1BE3D-AAD2-41CB-9E55-18986B5E219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6835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305EE-BB96-460C-B8F6-EF2AE0C23164}" type="datetimeFigureOut">
              <a:rPr lang="en-IN" smtClean="0"/>
              <a:t>21/12/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1BE3D-AAD2-41CB-9E55-18986B5E219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534922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C305EE-BB96-460C-B8F6-EF2AE0C23164}" type="datetimeFigureOut">
              <a:rPr lang="en-IN" smtClean="0"/>
              <a:t>21/12/22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71BE3D-AAD2-41CB-9E55-18986B5E219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25139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C305EE-BB96-460C-B8F6-EF2AE0C23164}" type="datetimeFigureOut">
              <a:rPr lang="en-IN" smtClean="0"/>
              <a:t>21/12/22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71BE3D-AAD2-41CB-9E55-18986B5E219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757530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75651" y="5328705"/>
            <a:ext cx="1101634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5. </a:t>
            </a:r>
            <a:r>
              <a:rPr lang="en-US" dirty="0"/>
              <a:t>Plasma Iron levels (by ICP-MS) across ACLF no-AKI, ACLF AKI and CLD patients. </a:t>
            </a:r>
          </a:p>
          <a:p>
            <a:r>
              <a:rPr lang="en-US" dirty="0"/>
              <a:t>Data is represented as median and interquartile range. Mann Whitney test was applied and p-value was computed. </a:t>
            </a:r>
          </a:p>
          <a:p>
            <a:r>
              <a:rPr lang="en-US" dirty="0"/>
              <a:t>P-value * = 0.018, p-value ** = 0.0098</a:t>
            </a:r>
            <a:endParaRPr lang="en-IN" dirty="0"/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1454892"/>
              </p:ext>
            </p:extLst>
          </p:nvPr>
        </p:nvGraphicFramePr>
        <p:xfrm>
          <a:off x="3403880" y="377976"/>
          <a:ext cx="5034886" cy="4649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3631609" imgH="3354115" progId="Prism6.Document">
                  <p:embed/>
                </p:oleObj>
              </mc:Choice>
              <mc:Fallback>
                <p:oleObj name="Prism 6" r:id="rId2" imgW="3631609" imgH="3354115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03880" y="377976"/>
                        <a:ext cx="5034886" cy="46497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5" name="Group 4">
            <a:extLst>
              <a:ext uri="{FF2B5EF4-FFF2-40B4-BE49-F238E27FC236}">
                <a16:creationId xmlns:a16="http://schemas.microsoft.com/office/drawing/2014/main" id="{B1A05832-6738-F349-D82D-46F39C966C68}"/>
              </a:ext>
            </a:extLst>
          </p:cNvPr>
          <p:cNvGrpSpPr/>
          <p:nvPr/>
        </p:nvGrpSpPr>
        <p:grpSpPr>
          <a:xfrm>
            <a:off x="4542509" y="4485191"/>
            <a:ext cx="1296364" cy="727238"/>
            <a:chOff x="4542509" y="4485191"/>
            <a:chExt cx="1296364" cy="727238"/>
          </a:xfrm>
        </p:grpSpPr>
        <p:sp>
          <p:nvSpPr>
            <p:cNvPr id="2" name="Right Brace 1">
              <a:extLst>
                <a:ext uri="{FF2B5EF4-FFF2-40B4-BE49-F238E27FC236}">
                  <a16:creationId xmlns:a16="http://schemas.microsoft.com/office/drawing/2014/main" id="{3F4C951A-7E47-B60A-7C3E-55B954386408}"/>
                </a:ext>
              </a:extLst>
            </p:cNvPr>
            <p:cNvSpPr/>
            <p:nvPr/>
          </p:nvSpPr>
          <p:spPr>
            <a:xfrm rot="5400000">
              <a:off x="5046007" y="3981693"/>
              <a:ext cx="289367" cy="1296364"/>
            </a:xfrm>
            <a:prstGeom prst="righ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213652B4-FBC0-03F1-2EF5-C66CB2C007E0}"/>
                </a:ext>
              </a:extLst>
            </p:cNvPr>
            <p:cNvSpPr txBox="1"/>
            <p:nvPr/>
          </p:nvSpPr>
          <p:spPr>
            <a:xfrm>
              <a:off x="4585635" y="4843097"/>
              <a:ext cx="12101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ACLF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154241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0</Words>
  <Application>Microsoft Macintosh PowerPoint</Application>
  <PresentationFormat>Widescreen</PresentationFormat>
  <Paragraphs>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6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novo-pc</dc:creator>
  <cp:lastModifiedBy>Pragyan Acharya</cp:lastModifiedBy>
  <cp:revision>5</cp:revision>
  <dcterms:created xsi:type="dcterms:W3CDTF">2022-12-15T10:07:34Z</dcterms:created>
  <dcterms:modified xsi:type="dcterms:W3CDTF">2022-12-21T11:38:50Z</dcterms:modified>
</cp:coreProperties>
</file>